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2"/>
    <p:restoredTop sz="94674"/>
  </p:normalViewPr>
  <p:slideViewPr>
    <p:cSldViewPr snapToGrid="0">
      <p:cViewPr varScale="1">
        <p:scale>
          <a:sx n="104" d="100"/>
          <a:sy n="104" d="100"/>
        </p:scale>
        <p:origin x="232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E1CBDEE-17E5-D524-61CE-3A0B92E389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C192A063-D87D-FD7E-FA3A-94EC489E01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76C541B-5AFF-7D7F-496B-5BFB8C26C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BA80357-330F-D400-8D0F-4F5F7511CE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CDB3A7C-B57A-73FF-DF49-E09806800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723191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567FDD5-A461-84F0-55BD-546FE4EA77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09E4D393-384D-7AE5-8180-F4407E7814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B1774CB-0B16-78F2-E602-833E06CC0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266AA53-51E4-93D7-F9E9-877520FE6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24F4510-53BE-81F1-232C-BC92D2D02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54483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94F59726-75B7-BEB6-A0AC-B4C5CD55EF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7E934046-393F-908E-21DE-6FF681FF33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742E58E-E496-8353-AC02-C7FF24D72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97FADE3-E1C8-E8C4-B46C-6A25E819C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0049F80-CE3A-A84D-50FB-AC2AC3CEE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283542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8253727-2D0B-EB5A-4292-14E73EFE1D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15289835-8E8E-20E9-1B29-F8E972A7B6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4AD521E-08B9-BE2D-2AB8-13663EE1A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79D756B-77EF-E1F6-31CF-5F9D6A9A5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42E353B-D471-D6D7-0ADD-E6C63F962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385503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51B347D-4005-5698-22F2-744B40320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EDEEFACB-DF75-AF44-1BC4-494C461912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21DF711-EEF7-3B5F-4DB6-D3314A8B2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4ADCE44A-AA12-2C68-53A7-8B0A4B85B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94BB5D93-A7CF-A857-1967-C14E3729C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779838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7D7EA24-4332-AC9A-4571-5CF6AFF5DC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6778371D-2211-99C7-9B14-C180A10976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172E5A1F-095C-0F0E-B5B7-A8882669C6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8209AA8C-B289-23A6-6129-238A3E72D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FD39541C-6FE7-0579-B426-F484FC0C7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ED56355D-EA9F-5315-486B-25BFEA669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039532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3AEFE7B-43E2-ECEE-AFC9-C53796B51C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C1F3E6A8-AD67-5704-DF2B-D6EC5A1EB5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938D2AB8-B93C-0E4A-4C95-FE667F32DD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627C6FEB-468F-FAF3-EDC3-F211D8AC97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C28EFC30-C232-76EB-8531-AAF8A82FC2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051E4BAB-3187-0F48-2E36-B3F7D90F5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02E8FEE8-5DB8-62A1-01C5-93F557B28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DBAA55A0-0444-25B7-05DE-40170F779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37474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2B7DC2C-0FF5-69D2-9C25-D760711E49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02375D95-34C0-69D7-F036-EBDAF0FE1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0BF2F10B-BC16-FBB4-D64D-3989846C0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40ED8C21-16CE-241A-DE6C-A16A6C49A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008474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96073BBC-BCA0-8C97-4ABE-CBE49E893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44C4717A-A79C-4DE4-6A87-0C96CDD70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F55EB83E-B08D-9B78-0B63-D0408EFB6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001797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85D00F3-0012-369F-4D8D-FED1FF0E9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DA0E7012-C09C-DC97-0726-4B60C955A5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DF9D8C86-CDAF-78E7-2645-08F704B5EC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16F2B08C-0A8C-CA1D-58FD-BADDFF952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CA2C1988-7393-9D89-A397-999005B9A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15AA545-70F1-7406-FFBE-EA86492E7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795755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A5CAF65-1AF6-A57C-F79A-DD5325A9BF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357E07BF-868D-3D0B-09B6-297716D178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473EF0AD-7A53-D212-7EF7-4743A0F8E9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3E021809-E579-81AF-BDB1-C7236DDAD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B3BBC93-D2C4-031D-6A1B-4A1F37E4C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CA8DB047-E182-9399-1F9F-6BD47C92C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824658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74EED950-2232-1A1E-A344-EB16BF9BB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DD205C8D-5A28-C42D-8B26-1C2AF77D84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0672D0D-E2A9-E28D-EAA5-57CA46D044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6278F1-B648-8949-B204-C78BD1862F53}" type="datetimeFigureOut">
              <a:rPr kumimoji="1" lang="zh-TW" altLang="en-US" smtClean="0"/>
              <a:t>2024/5/1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9E0E216-BF78-323C-0129-F720FA394C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2878BEC-BE09-16A0-D472-527FDD2613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D8275C-DA69-7A4F-AE2A-04790105994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807328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圖片 9" descr="一張含有 光線, 藝術, 室內 的圖片&#10;&#10;自動產生的描述">
            <a:extLst>
              <a:ext uri="{FF2B5EF4-FFF2-40B4-BE49-F238E27FC236}">
                <a16:creationId xmlns:a16="http://schemas.microsoft.com/office/drawing/2014/main" id="{7AB38F68-2D37-D2D9-D98A-F0D3D3E979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4462" y="0"/>
            <a:ext cx="5143075" cy="6858000"/>
          </a:xfrm>
          <a:prstGeom prst="rect">
            <a:avLst/>
          </a:prstGeom>
        </p:spPr>
      </p:pic>
      <p:sp>
        <p:nvSpPr>
          <p:cNvPr id="11" name="文字方塊 10">
            <a:extLst>
              <a:ext uri="{FF2B5EF4-FFF2-40B4-BE49-F238E27FC236}">
                <a16:creationId xmlns:a16="http://schemas.microsoft.com/office/drawing/2014/main" id="{A3AC1ED2-CAC7-124D-59FE-41BDAD991221}"/>
              </a:ext>
            </a:extLst>
          </p:cNvPr>
          <p:cNvSpPr txBox="1"/>
          <p:nvPr/>
        </p:nvSpPr>
        <p:spPr>
          <a:xfrm>
            <a:off x="762000" y="512618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err="1"/>
              <a:t>fGal_aug</a:t>
            </a:r>
            <a:endParaRPr kumimoji="1" lang="en-US" altLang="zh-TW" dirty="0"/>
          </a:p>
        </p:txBody>
      </p:sp>
    </p:spTree>
    <p:extLst>
      <p:ext uri="{BB962C8B-B14F-4D97-AF65-F5344CB8AC3E}">
        <p14:creationId xmlns:p14="http://schemas.microsoft.com/office/powerpoint/2010/main" val="3748129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一張含有 行, 藝術, 光線 的圖片&#10;&#10;自動產生的描述">
            <a:extLst>
              <a:ext uri="{FF2B5EF4-FFF2-40B4-BE49-F238E27FC236}">
                <a16:creationId xmlns:a16="http://schemas.microsoft.com/office/drawing/2014/main" id="{2E4A790F-AB93-BC83-9484-EDB5463C51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4462" y="1387"/>
            <a:ext cx="5143075" cy="6858000"/>
          </a:xfrm>
          <a:prstGeom prst="rect">
            <a:avLst/>
          </a:prstGeom>
        </p:spPr>
      </p:pic>
      <p:sp>
        <p:nvSpPr>
          <p:cNvPr id="3" name="文字方塊 2">
            <a:extLst>
              <a:ext uri="{FF2B5EF4-FFF2-40B4-BE49-F238E27FC236}">
                <a16:creationId xmlns:a16="http://schemas.microsoft.com/office/drawing/2014/main" id="{6A289674-D3E1-76F7-9A0A-81354D2DA6F8}"/>
              </a:ext>
            </a:extLst>
          </p:cNvPr>
          <p:cNvSpPr txBox="1"/>
          <p:nvPr/>
        </p:nvSpPr>
        <p:spPr>
          <a:xfrm>
            <a:off x="762000" y="512618"/>
            <a:ext cx="3061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err="1"/>
              <a:t>fGal_aug+LPS</a:t>
            </a:r>
            <a:r>
              <a:rPr kumimoji="1" lang="en-US" altLang="zh-TW" dirty="0"/>
              <a:t>(0.2mg/ml)</a:t>
            </a:r>
          </a:p>
        </p:txBody>
      </p:sp>
    </p:spTree>
    <p:extLst>
      <p:ext uri="{BB962C8B-B14F-4D97-AF65-F5344CB8AC3E}">
        <p14:creationId xmlns:p14="http://schemas.microsoft.com/office/powerpoint/2010/main" val="37123642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一張含有 藝術 的圖片&#10;&#10;自動產生的描述">
            <a:extLst>
              <a:ext uri="{FF2B5EF4-FFF2-40B4-BE49-F238E27FC236}">
                <a16:creationId xmlns:a16="http://schemas.microsoft.com/office/drawing/2014/main" id="{FDD433D5-A936-4DD1-9A1A-AE15F93F87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4462" y="0"/>
            <a:ext cx="5143075" cy="6858000"/>
          </a:xfrm>
          <a:prstGeom prst="rect">
            <a:avLst/>
          </a:prstGeom>
        </p:spPr>
      </p:pic>
      <p:sp>
        <p:nvSpPr>
          <p:cNvPr id="3" name="文字方塊 2">
            <a:extLst>
              <a:ext uri="{FF2B5EF4-FFF2-40B4-BE49-F238E27FC236}">
                <a16:creationId xmlns:a16="http://schemas.microsoft.com/office/drawing/2014/main" id="{D09E5648-8DFC-5E30-B0AB-8F342F8236B8}"/>
              </a:ext>
            </a:extLst>
          </p:cNvPr>
          <p:cNvSpPr txBox="1"/>
          <p:nvPr/>
        </p:nvSpPr>
        <p:spPr>
          <a:xfrm>
            <a:off x="762000" y="512618"/>
            <a:ext cx="30618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err="1"/>
              <a:t>fGal_aug</a:t>
            </a:r>
            <a:endParaRPr kumimoji="1" lang="en-US" altLang="zh-TW" dirty="0"/>
          </a:p>
          <a:p>
            <a:r>
              <a:rPr kumimoji="1" lang="en-US" altLang="zh-TW" dirty="0"/>
              <a:t>+LPS(0.2mg/ml)</a:t>
            </a:r>
          </a:p>
          <a:p>
            <a:r>
              <a:rPr kumimoji="1" lang="en-US" altLang="zh-TW" dirty="0"/>
              <a:t>+lactose(25mM)</a:t>
            </a:r>
          </a:p>
        </p:txBody>
      </p:sp>
    </p:spTree>
    <p:extLst>
      <p:ext uri="{BB962C8B-B14F-4D97-AF65-F5344CB8AC3E}">
        <p14:creationId xmlns:p14="http://schemas.microsoft.com/office/powerpoint/2010/main" val="33510399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 descr="一張含有 藝術 的圖片&#10;&#10;描述是以低可信度自動產生">
            <a:extLst>
              <a:ext uri="{FF2B5EF4-FFF2-40B4-BE49-F238E27FC236}">
                <a16:creationId xmlns:a16="http://schemas.microsoft.com/office/drawing/2014/main" id="{B4373565-EF0A-CF7C-79C2-C39229963A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2667000" y="897666"/>
            <a:ext cx="6858000" cy="5143500"/>
          </a:xfrm>
          <a:prstGeom prst="rect">
            <a:avLst/>
          </a:prstGeom>
        </p:spPr>
      </p:pic>
      <p:sp>
        <p:nvSpPr>
          <p:cNvPr id="4" name="文字方塊 3">
            <a:extLst>
              <a:ext uri="{FF2B5EF4-FFF2-40B4-BE49-F238E27FC236}">
                <a16:creationId xmlns:a16="http://schemas.microsoft.com/office/drawing/2014/main" id="{27FE0547-69B8-EA70-C703-2BDF819EB32D}"/>
              </a:ext>
            </a:extLst>
          </p:cNvPr>
          <p:cNvSpPr txBox="1"/>
          <p:nvPr/>
        </p:nvSpPr>
        <p:spPr>
          <a:xfrm>
            <a:off x="4795058" y="3675156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</a:t>
            </a:r>
            <a:endParaRPr kumimoji="1" lang="en-US" altLang="zh-TW" dirty="0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9C07485B-4152-ED42-C445-37008C437B8C}"/>
              </a:ext>
            </a:extLst>
          </p:cNvPr>
          <p:cNvSpPr txBox="1"/>
          <p:nvPr/>
        </p:nvSpPr>
        <p:spPr>
          <a:xfrm>
            <a:off x="6908654" y="3675156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_aug</a:t>
            </a:r>
            <a:endParaRPr kumimoji="1" lang="en-US" altLang="zh-TW" dirty="0"/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B42EC260-97ED-789F-3E5F-CA9CBB6C6754}"/>
              </a:ext>
            </a:extLst>
          </p:cNvPr>
          <p:cNvSpPr txBox="1"/>
          <p:nvPr/>
        </p:nvSpPr>
        <p:spPr>
          <a:xfrm>
            <a:off x="5934767" y="3675156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_W</a:t>
            </a:r>
            <a:r>
              <a:rPr kumimoji="1" lang="en-US" altLang="zh-TW" dirty="0"/>
              <a:t>/Y</a:t>
            </a: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FC2C15A4-4E29-7C9D-5A08-0FF7A5262751}"/>
              </a:ext>
            </a:extLst>
          </p:cNvPr>
          <p:cNvSpPr txBox="1"/>
          <p:nvPr/>
        </p:nvSpPr>
        <p:spPr>
          <a:xfrm>
            <a:off x="3771639" y="3675156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hGal</a:t>
            </a:r>
            <a:endParaRPr kumimoji="1" lang="en-US" altLang="zh-TW" dirty="0"/>
          </a:p>
        </p:txBody>
      </p:sp>
    </p:spTree>
    <p:extLst>
      <p:ext uri="{BB962C8B-B14F-4D97-AF65-F5344CB8AC3E}">
        <p14:creationId xmlns:p14="http://schemas.microsoft.com/office/powerpoint/2010/main" val="21119829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 descr="一張含有 室內, 家用電器, 纜線, 攪拌機 的圖片&#10;&#10;自動產生的描述">
            <a:extLst>
              <a:ext uri="{FF2B5EF4-FFF2-40B4-BE49-F238E27FC236}">
                <a16:creationId xmlns:a16="http://schemas.microsoft.com/office/drawing/2014/main" id="{71E0E1FA-D8A2-9B10-0C64-42208EEE0B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3334" t="26815" r="49999" b="24287"/>
          <a:stretch/>
        </p:blipFill>
        <p:spPr>
          <a:xfrm rot="16200000">
            <a:off x="3627078" y="-672030"/>
            <a:ext cx="4340545" cy="9550799"/>
          </a:xfrm>
          <a:prstGeom prst="rect">
            <a:avLst/>
          </a:prstGeom>
        </p:spPr>
      </p:pic>
      <p:sp>
        <p:nvSpPr>
          <p:cNvPr id="4" name="文字方塊 3">
            <a:extLst>
              <a:ext uri="{FF2B5EF4-FFF2-40B4-BE49-F238E27FC236}">
                <a16:creationId xmlns:a16="http://schemas.microsoft.com/office/drawing/2014/main" id="{A8B25E4A-F4E2-99DC-FD1A-C0577E2F95CD}"/>
              </a:ext>
            </a:extLst>
          </p:cNvPr>
          <p:cNvSpPr txBox="1"/>
          <p:nvPr/>
        </p:nvSpPr>
        <p:spPr>
          <a:xfrm>
            <a:off x="3162992" y="2571497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</a:t>
            </a:r>
            <a:endParaRPr kumimoji="1" lang="en-US" altLang="zh-TW" dirty="0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1972CB81-802A-99B1-2F8F-C80297CA5299}"/>
              </a:ext>
            </a:extLst>
          </p:cNvPr>
          <p:cNvSpPr txBox="1"/>
          <p:nvPr/>
        </p:nvSpPr>
        <p:spPr>
          <a:xfrm>
            <a:off x="7858280" y="2571497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_aug</a:t>
            </a:r>
            <a:endParaRPr kumimoji="1" lang="en-US" altLang="zh-TW" dirty="0"/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934B411C-8300-D9E0-4299-5DE7A52E14CE}"/>
              </a:ext>
            </a:extLst>
          </p:cNvPr>
          <p:cNvSpPr txBox="1"/>
          <p:nvPr/>
        </p:nvSpPr>
        <p:spPr>
          <a:xfrm>
            <a:off x="5361003" y="2571497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_W</a:t>
            </a:r>
            <a:r>
              <a:rPr kumimoji="1" lang="en-US" altLang="zh-TW" dirty="0"/>
              <a:t>/Y</a:t>
            </a: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DC17D58B-95AA-C261-18E3-3D67AB11D940}"/>
              </a:ext>
            </a:extLst>
          </p:cNvPr>
          <p:cNvSpPr txBox="1"/>
          <p:nvPr/>
        </p:nvSpPr>
        <p:spPr>
          <a:xfrm>
            <a:off x="964981" y="2571497"/>
            <a:ext cx="1593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hGal</a:t>
            </a:r>
            <a:endParaRPr kumimoji="1" lang="en-US" altLang="zh-TW" dirty="0"/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F6DFAC64-9F9C-23DB-4104-D1AF7940C008}"/>
              </a:ext>
            </a:extLst>
          </p:cNvPr>
          <p:cNvSpPr txBox="1"/>
          <p:nvPr/>
        </p:nvSpPr>
        <p:spPr>
          <a:xfrm>
            <a:off x="4261998" y="2432998"/>
            <a:ext cx="15932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</a:t>
            </a:r>
            <a:endParaRPr kumimoji="1" lang="en-US" altLang="zh-TW" dirty="0"/>
          </a:p>
          <a:p>
            <a:pPr algn="ctr"/>
            <a:r>
              <a:rPr kumimoji="1" lang="en-US" altLang="zh-TW" dirty="0"/>
              <a:t>+LPS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C0A3A60C-4601-9BD5-2041-0F7E9CE241C8}"/>
              </a:ext>
            </a:extLst>
          </p:cNvPr>
          <p:cNvSpPr txBox="1"/>
          <p:nvPr/>
        </p:nvSpPr>
        <p:spPr>
          <a:xfrm>
            <a:off x="9052204" y="2432998"/>
            <a:ext cx="15932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_aug</a:t>
            </a:r>
            <a:endParaRPr kumimoji="1" lang="en-US" altLang="zh-TW" dirty="0"/>
          </a:p>
          <a:p>
            <a:pPr algn="ctr"/>
            <a:r>
              <a:rPr kumimoji="1" lang="en-US" altLang="zh-TW" dirty="0"/>
              <a:t>+LPS</a:t>
            </a: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977D9B08-D9B8-7BBB-7A78-03ACF3F575DB}"/>
              </a:ext>
            </a:extLst>
          </p:cNvPr>
          <p:cNvSpPr txBox="1"/>
          <p:nvPr/>
        </p:nvSpPr>
        <p:spPr>
          <a:xfrm>
            <a:off x="6539169" y="2432998"/>
            <a:ext cx="15932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fGal_W</a:t>
            </a:r>
            <a:r>
              <a:rPr kumimoji="1" lang="en-US" altLang="zh-TW" dirty="0"/>
              <a:t>/Y</a:t>
            </a:r>
          </a:p>
          <a:p>
            <a:pPr algn="ctr"/>
            <a:r>
              <a:rPr kumimoji="1" lang="en-US" altLang="zh-TW" dirty="0"/>
              <a:t>+LPS</a:t>
            </a: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E1F9BC1B-00C4-74B7-08D0-82172243BD8F}"/>
              </a:ext>
            </a:extLst>
          </p:cNvPr>
          <p:cNvSpPr txBox="1"/>
          <p:nvPr/>
        </p:nvSpPr>
        <p:spPr>
          <a:xfrm>
            <a:off x="1874774" y="2432998"/>
            <a:ext cx="15932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 err="1"/>
              <a:t>hGal</a:t>
            </a:r>
            <a:endParaRPr kumimoji="1" lang="en-US" altLang="zh-TW" dirty="0"/>
          </a:p>
          <a:p>
            <a:pPr algn="ctr"/>
            <a:r>
              <a:rPr kumimoji="1" lang="en-US" altLang="zh-TW" dirty="0"/>
              <a:t>+LPS</a:t>
            </a:r>
          </a:p>
        </p:txBody>
      </p:sp>
    </p:spTree>
    <p:extLst>
      <p:ext uri="{BB962C8B-B14F-4D97-AF65-F5344CB8AC3E}">
        <p14:creationId xmlns:p14="http://schemas.microsoft.com/office/powerpoint/2010/main" val="1676426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66</Words>
  <Application>Microsoft Macintosh PowerPoint</Application>
  <PresentationFormat>寬螢幕</PresentationFormat>
  <Paragraphs>21</Paragraphs>
  <Slides>5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林煜皓</dc:creator>
  <cp:lastModifiedBy>Jie-rong Huang</cp:lastModifiedBy>
  <cp:revision>4</cp:revision>
  <dcterms:created xsi:type="dcterms:W3CDTF">2024-05-14T07:42:35Z</dcterms:created>
  <dcterms:modified xsi:type="dcterms:W3CDTF">2024-05-14T08:38:59Z</dcterms:modified>
</cp:coreProperties>
</file>